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010"/>
    <p:restoredTop sz="94661"/>
  </p:normalViewPr>
  <p:slideViewPr>
    <p:cSldViewPr snapToGrid="0">
      <p:cViewPr varScale="1">
        <p:scale>
          <a:sx n="85" d="100"/>
          <a:sy n="85" d="100"/>
        </p:scale>
        <p:origin x="349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590F2-2B37-2341-8851-51CCBA58EC21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248A5-B71B-E84D-B369-545FBDEF31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1149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590F2-2B37-2341-8851-51CCBA58EC21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248A5-B71B-E84D-B369-545FBDEF31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4539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590F2-2B37-2341-8851-51CCBA58EC21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248A5-B71B-E84D-B369-545FBDEF31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6232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590F2-2B37-2341-8851-51CCBA58EC21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248A5-B71B-E84D-B369-545FBDEF31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3965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590F2-2B37-2341-8851-51CCBA58EC21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248A5-B71B-E84D-B369-545FBDEF31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0545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590F2-2B37-2341-8851-51CCBA58EC21}" type="datetimeFigureOut">
              <a:rPr lang="en-US" smtClean="0"/>
              <a:t>1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248A5-B71B-E84D-B369-545FBDEF31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831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590F2-2B37-2341-8851-51CCBA58EC21}" type="datetimeFigureOut">
              <a:rPr lang="en-US" smtClean="0"/>
              <a:t>1/21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248A5-B71B-E84D-B369-545FBDEF31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963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590F2-2B37-2341-8851-51CCBA58EC21}" type="datetimeFigureOut">
              <a:rPr lang="en-US" smtClean="0"/>
              <a:t>1/21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248A5-B71B-E84D-B369-545FBDEF31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95031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590F2-2B37-2341-8851-51CCBA58EC21}" type="datetimeFigureOut">
              <a:rPr lang="en-US" smtClean="0"/>
              <a:t>1/21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248A5-B71B-E84D-B369-545FBDEF31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50513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590F2-2B37-2341-8851-51CCBA58EC21}" type="datetimeFigureOut">
              <a:rPr lang="en-US" smtClean="0"/>
              <a:t>1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248A5-B71B-E84D-B369-545FBDEF31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9656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A590F2-2B37-2341-8851-51CCBA58EC21}" type="datetimeFigureOut">
              <a:rPr lang="en-US" smtClean="0"/>
              <a:t>1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C248A5-B71B-E84D-B369-545FBDEF31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6222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2A590F2-2B37-2341-8851-51CCBA58EC21}" type="datetimeFigureOut">
              <a:rPr lang="en-US" smtClean="0"/>
              <a:t>1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1C248A5-B71B-E84D-B369-545FBDEF31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6506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>
            <a:extLst>
              <a:ext uri="{FF2B5EF4-FFF2-40B4-BE49-F238E27FC236}">
                <a16:creationId xmlns:a16="http://schemas.microsoft.com/office/drawing/2014/main" id="{247CCE5E-FA26-5B4D-2C5E-1732EF3ABC34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84114" t="46838" r="13951" b="42686"/>
          <a:stretch/>
        </p:blipFill>
        <p:spPr>
          <a:xfrm rot="5400000">
            <a:off x="1190779" y="8443067"/>
            <a:ext cx="218581" cy="914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8B5AD62-FC5E-0B0E-A76D-4B1DE4BE82B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926" t="2730" r="15556" b="5964"/>
          <a:stretch/>
        </p:blipFill>
        <p:spPr>
          <a:xfrm flipH="1">
            <a:off x="392250" y="952503"/>
            <a:ext cx="6002049" cy="768096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13FF7A6-0F6C-E8F5-2EE5-F5F390161D05}"/>
              </a:ext>
            </a:extLst>
          </p:cNvPr>
          <p:cNvSpPr txBox="1"/>
          <p:nvPr/>
        </p:nvSpPr>
        <p:spPr>
          <a:xfrm rot="16200000">
            <a:off x="-323627" y="4380447"/>
            <a:ext cx="11840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utoantibodie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3F09D04-7985-FEB9-B207-6E63D3277B3B}"/>
              </a:ext>
            </a:extLst>
          </p:cNvPr>
          <p:cNvSpPr txBox="1"/>
          <p:nvPr/>
        </p:nvSpPr>
        <p:spPr>
          <a:xfrm>
            <a:off x="298284" y="500918"/>
            <a:ext cx="47961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Study ID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0440E47-81C5-7464-2BD9-6E39837CCF20}"/>
              </a:ext>
            </a:extLst>
          </p:cNvPr>
          <p:cNvSpPr txBox="1"/>
          <p:nvPr/>
        </p:nvSpPr>
        <p:spPr>
          <a:xfrm>
            <a:off x="73862" y="613643"/>
            <a:ext cx="7040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Active disease: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F1EAF37-BBC4-59F5-DE6E-BE2A7A2BA476}"/>
              </a:ext>
            </a:extLst>
          </p:cNvPr>
          <p:cNvSpPr txBox="1"/>
          <p:nvPr/>
        </p:nvSpPr>
        <p:spPr>
          <a:xfrm>
            <a:off x="123556" y="726368"/>
            <a:ext cx="65434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On treatment: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5DD1A37-6B58-F2C2-DAA6-A0EF8925B5ED}"/>
              </a:ext>
            </a:extLst>
          </p:cNvPr>
          <p:cNvSpPr txBox="1"/>
          <p:nvPr/>
        </p:nvSpPr>
        <p:spPr>
          <a:xfrm>
            <a:off x="192485" y="839094"/>
            <a:ext cx="58541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Monogenic: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7C739DD-071B-9DFD-0648-EBD70EE1BEF0}"/>
              </a:ext>
            </a:extLst>
          </p:cNvPr>
          <p:cNvSpPr txBox="1"/>
          <p:nvPr/>
        </p:nvSpPr>
        <p:spPr>
          <a:xfrm>
            <a:off x="609367" y="8645664"/>
            <a:ext cx="14927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IgG Normalized Intensity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8243DDC-DC38-5BD2-A571-AC4D082006B5}"/>
              </a:ext>
            </a:extLst>
          </p:cNvPr>
          <p:cNvSpPr txBox="1"/>
          <p:nvPr/>
        </p:nvSpPr>
        <p:spPr>
          <a:xfrm>
            <a:off x="1480535" y="8947739"/>
            <a:ext cx="38824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&gt;8.5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71E48AF-1588-7762-AA53-749ED38F8D82}"/>
              </a:ext>
            </a:extLst>
          </p:cNvPr>
          <p:cNvSpPr txBox="1"/>
          <p:nvPr/>
        </p:nvSpPr>
        <p:spPr>
          <a:xfrm>
            <a:off x="1141194" y="8947739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.5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8B7D5F8-1A7D-6013-4651-CED0BBA6F712}"/>
              </a:ext>
            </a:extLst>
          </p:cNvPr>
          <p:cNvSpPr txBox="1"/>
          <p:nvPr/>
        </p:nvSpPr>
        <p:spPr>
          <a:xfrm>
            <a:off x="736955" y="8947739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.5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CB1CE5B-ACB9-5E7C-6199-0219329DBB14}"/>
              </a:ext>
            </a:extLst>
          </p:cNvPr>
          <p:cNvSpPr txBox="1"/>
          <p:nvPr/>
        </p:nvSpPr>
        <p:spPr>
          <a:xfrm>
            <a:off x="-32320" y="21252"/>
            <a:ext cx="16401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88FAABE1-42CA-0777-3FE1-817417C20EF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1099" y="522197"/>
            <a:ext cx="5641848" cy="483703"/>
          </a:xfrm>
          <a:prstGeom prst="rect">
            <a:avLst/>
          </a:prstGeom>
        </p:spPr>
      </p:pic>
      <p:sp>
        <p:nvSpPr>
          <p:cNvPr id="30" name="Rectangle 29">
            <a:extLst>
              <a:ext uri="{FF2B5EF4-FFF2-40B4-BE49-F238E27FC236}">
                <a16:creationId xmlns:a16="http://schemas.microsoft.com/office/drawing/2014/main" id="{42F11C54-78FD-A7D6-37E5-B6CCE55F795B}"/>
              </a:ext>
            </a:extLst>
          </p:cNvPr>
          <p:cNvSpPr>
            <a:spLocks noChangeAspect="1"/>
          </p:cNvSpPr>
          <p:nvPr/>
        </p:nvSpPr>
        <p:spPr>
          <a:xfrm>
            <a:off x="6400275" y="653679"/>
            <a:ext cx="91440" cy="91440"/>
          </a:xfrm>
          <a:prstGeom prst="rect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7CD4440F-033F-FC06-6065-A294BD50FD2F}"/>
              </a:ext>
            </a:extLst>
          </p:cNvPr>
          <p:cNvSpPr>
            <a:spLocks noChangeAspect="1"/>
          </p:cNvSpPr>
          <p:nvPr/>
        </p:nvSpPr>
        <p:spPr>
          <a:xfrm>
            <a:off x="6400275" y="887361"/>
            <a:ext cx="91440" cy="91440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F9B3BC9F-FEC1-305C-D23D-636C79C40941}"/>
              </a:ext>
            </a:extLst>
          </p:cNvPr>
          <p:cNvSpPr>
            <a:spLocks noChangeAspect="1"/>
          </p:cNvSpPr>
          <p:nvPr/>
        </p:nvSpPr>
        <p:spPr>
          <a:xfrm>
            <a:off x="6400275" y="770520"/>
            <a:ext cx="91440" cy="91440"/>
          </a:xfrm>
          <a:prstGeom prst="rect">
            <a:avLst/>
          </a:prstGeom>
          <a:solidFill>
            <a:schemeClr val="bg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53351BB-9F7C-832C-4C0A-C7440BBD34DB}"/>
              </a:ext>
            </a:extLst>
          </p:cNvPr>
          <p:cNvSpPr txBox="1"/>
          <p:nvPr/>
        </p:nvSpPr>
        <p:spPr>
          <a:xfrm>
            <a:off x="6427514" y="594817"/>
            <a:ext cx="3385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Yes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49BD5F5-231F-7D5A-BDF9-4031DA1C52C6}"/>
              </a:ext>
            </a:extLst>
          </p:cNvPr>
          <p:cNvSpPr txBox="1"/>
          <p:nvPr/>
        </p:nvSpPr>
        <p:spPr>
          <a:xfrm>
            <a:off x="6427514" y="716773"/>
            <a:ext cx="29848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A2DC550-3AC1-1FC8-2401-CBAB30C3C96F}"/>
              </a:ext>
            </a:extLst>
          </p:cNvPr>
          <p:cNvSpPr txBox="1"/>
          <p:nvPr/>
        </p:nvSpPr>
        <p:spPr>
          <a:xfrm>
            <a:off x="6427514" y="838729"/>
            <a:ext cx="4732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</p:spTree>
    <p:extLst>
      <p:ext uri="{BB962C8B-B14F-4D97-AF65-F5344CB8AC3E}">
        <p14:creationId xmlns:p14="http://schemas.microsoft.com/office/powerpoint/2010/main" val="22274840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3</TotalTime>
  <Words>24</Words>
  <Application>Microsoft Macintosh PowerPoint</Application>
  <PresentationFormat>Letter Paper (8.5x11 in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u, Janet</dc:creator>
  <cp:lastModifiedBy>Chamseddine, Sarah,MD</cp:lastModifiedBy>
  <cp:revision>8</cp:revision>
  <dcterms:created xsi:type="dcterms:W3CDTF">2024-10-30T23:16:01Z</dcterms:created>
  <dcterms:modified xsi:type="dcterms:W3CDTF">2025-01-21T15:12:17Z</dcterms:modified>
</cp:coreProperties>
</file>